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58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49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02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892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067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539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573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550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762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295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84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D2834-22C8-4EC9-A7A9-543EC6DA8F65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0CCF83-6066-4F57-B423-A2E4032A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373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463691" y="103198"/>
            <a:ext cx="458763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1a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of immune cell populations analyzed by flow cytometry. </a:t>
            </a:r>
          </a:p>
          <a:p>
            <a:pPr algn="just"/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 subsets were determined through FSC-A/SSC-A plot, followed by doublet discrimination through FSC-H/SSC-H and FSC-W/SSC-W. Subsequently dead cells were excluded by using the BD Horizon™ Fixable Viability Stain 780. Live cells were then gated against CD45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rker. Within the CD45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 population, Bu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CD8α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gated. From the total CD8α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, the CD8α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CRγδ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ubpopulation was gated as indicated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-135008" y="16623"/>
            <a:ext cx="586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smtClean="0"/>
              <a:t>a)</a:t>
            </a:r>
            <a:endParaRPr lang="en-GB" sz="2000" b="1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073" y="16623"/>
            <a:ext cx="6846438" cy="672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33023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027" y="257907"/>
            <a:ext cx="6525425" cy="411565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057291" y="257907"/>
            <a:ext cx="501747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1b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 of immune cell populations analyzed by flow cytometry. </a:t>
            </a:r>
          </a:p>
          <a:p>
            <a:pPr algn="just"/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nocytes/macrophages were determined by applying an extended FSC-A/SSC-A plot (given the size of the cells) followed by doublet discrimination through FSC-H/SSC-H and FSC-W/SSC-W. Dead cells were excluded by using the BD Horizon™ Fixable Viability Stain 780. Live cells were then gated against CD45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rker, and subsequently for the monocytes/macrophage (Kul01) popula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35008" y="16623"/>
            <a:ext cx="586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 smtClean="0"/>
              <a:t>b)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1065739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ra Taniya</dc:creator>
  <cp:lastModifiedBy>De Luca Carlotta</cp:lastModifiedBy>
  <cp:revision>43</cp:revision>
  <dcterms:created xsi:type="dcterms:W3CDTF">2022-05-19T15:57:44Z</dcterms:created>
  <dcterms:modified xsi:type="dcterms:W3CDTF">2022-08-23T10:21:06Z</dcterms:modified>
</cp:coreProperties>
</file>